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8" r:id="rId2"/>
    <p:sldId id="279" r:id="rId3"/>
    <p:sldId id="280" r:id="rId4"/>
    <p:sldId id="257" r:id="rId5"/>
    <p:sldId id="258" r:id="rId6"/>
    <p:sldId id="277" r:id="rId7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37" d="100"/>
          <a:sy n="37" d="100"/>
        </p:scale>
        <p:origin x="240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92DF41-7144-4B5B-90B0-60BF8BF9534F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22E0-6F89-4400-877A-5ED95907F4A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14617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92DF41-7144-4B5B-90B0-60BF8BF9534F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22E0-6F89-4400-877A-5ED95907F4A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94484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92DF41-7144-4B5B-90B0-60BF8BF9534F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22E0-6F89-4400-877A-5ED95907F4A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22321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92DF41-7144-4B5B-90B0-60BF8BF9534F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22E0-6F89-4400-877A-5ED95907F4A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68432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92DF41-7144-4B5B-90B0-60BF8BF9534F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22E0-6F89-4400-877A-5ED95907F4A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04697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92DF41-7144-4B5B-90B0-60BF8BF9534F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22E0-6F89-4400-877A-5ED95907F4A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13605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92DF41-7144-4B5B-90B0-60BF8BF9534F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22E0-6F89-4400-877A-5ED95907F4A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25048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92DF41-7144-4B5B-90B0-60BF8BF9534F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22E0-6F89-4400-877A-5ED95907F4A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39164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92DF41-7144-4B5B-90B0-60BF8BF9534F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22E0-6F89-4400-877A-5ED95907F4A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49589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92DF41-7144-4B5B-90B0-60BF8BF9534F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22E0-6F89-4400-877A-5ED95907F4A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29662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92DF41-7144-4B5B-90B0-60BF8BF9534F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E22E0-6F89-4400-877A-5ED95907F4A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70926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92DF41-7144-4B5B-90B0-60BF8BF9534F}" type="datetimeFigureOut">
              <a:rPr lang="en-IN" smtClean="0"/>
              <a:t>06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EE22E0-6F89-4400-877A-5ED95907F4A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8939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CC3D83C-F2AE-03B4-09C3-83DB87E39E96}"/>
              </a:ext>
            </a:extLst>
          </p:cNvPr>
          <p:cNvSpPr txBox="1"/>
          <p:nvPr/>
        </p:nvSpPr>
        <p:spPr>
          <a:xfrm>
            <a:off x="510321" y="4422717"/>
            <a:ext cx="37611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Figure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0EF0063-A37B-7504-6F58-2CAF0312ECDB}"/>
              </a:ext>
            </a:extLst>
          </p:cNvPr>
          <p:cNvSpPr txBox="1"/>
          <p:nvPr/>
        </p:nvSpPr>
        <p:spPr>
          <a:xfrm>
            <a:off x="161223" y="4985886"/>
            <a:ext cx="653555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.</a:t>
            </a:r>
            <a:r>
              <a:rPr lang="en-I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:</a:t>
            </a:r>
            <a:r>
              <a:rPr lang="en-I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 complete workflow followed for the identification of miRNAs under drought stress and their target genes specific to the known major </a:t>
            </a:r>
            <a:r>
              <a:rPr lang="en-IN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antitaive</a:t>
            </a:r>
            <a:r>
              <a:rPr lang="en-I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iat</a:t>
            </a:r>
            <a:r>
              <a:rPr lang="en-I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oci for drought stress tolerance</a:t>
            </a:r>
            <a:endParaRPr lang="en-IN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IN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23216FB-549E-811C-A1E2-CC0239B6ED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0850" y="1351317"/>
            <a:ext cx="4959350" cy="34407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98507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4B23FD60-17C5-934F-998D-87131012A8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791" y="572224"/>
            <a:ext cx="6445581" cy="2457576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57EBA324-1E1F-CB6E-BFD9-AD506C71B48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50" t="5226"/>
          <a:stretch/>
        </p:blipFill>
        <p:spPr>
          <a:xfrm>
            <a:off x="113791" y="4071670"/>
            <a:ext cx="6445581" cy="2329142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0176F62-5CEC-945A-8A86-03B5059535C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3791" y="7073714"/>
            <a:ext cx="6445581" cy="1673453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B455B5BB-C837-3551-6FD7-435B41FBD4C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3791" y="9241361"/>
            <a:ext cx="6445581" cy="1714588"/>
          </a:xfrm>
          <a:prstGeom prst="rect">
            <a:avLst/>
          </a:prstGeom>
          <a:ln>
            <a:solidFill>
              <a:srgbClr val="FF0000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AE158A67-C978-5770-D726-C888DF484D86}"/>
              </a:ext>
            </a:extLst>
          </p:cNvPr>
          <p:cNvSpPr txBox="1"/>
          <p:nvPr/>
        </p:nvSpPr>
        <p:spPr>
          <a:xfrm>
            <a:off x="116668" y="207034"/>
            <a:ext cx="366412" cy="323165"/>
          </a:xfrm>
          <a:prstGeom prst="rect">
            <a:avLst/>
          </a:prstGeom>
          <a:solidFill>
            <a:schemeClr val="accent2"/>
          </a:solidFill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2E3B885-C386-A3B6-5379-134D51286FB9}"/>
              </a:ext>
            </a:extLst>
          </p:cNvPr>
          <p:cNvSpPr txBox="1"/>
          <p:nvPr/>
        </p:nvSpPr>
        <p:spPr>
          <a:xfrm>
            <a:off x="113790" y="3702702"/>
            <a:ext cx="369289" cy="326943"/>
          </a:xfrm>
          <a:prstGeom prst="rect">
            <a:avLst/>
          </a:prstGeom>
          <a:solidFill>
            <a:schemeClr val="accent2"/>
          </a:solidFill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2F5AE1C-24D1-B7FB-81F1-F4F5E40D9D80}"/>
              </a:ext>
            </a:extLst>
          </p:cNvPr>
          <p:cNvSpPr txBox="1"/>
          <p:nvPr/>
        </p:nvSpPr>
        <p:spPr>
          <a:xfrm>
            <a:off x="110913" y="6719072"/>
            <a:ext cx="369289" cy="326943"/>
          </a:xfrm>
          <a:prstGeom prst="rect">
            <a:avLst/>
          </a:prstGeom>
          <a:solidFill>
            <a:schemeClr val="accent2"/>
          </a:solidFill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5543ACB-CD81-4FCC-11D7-794648732B7A}"/>
              </a:ext>
            </a:extLst>
          </p:cNvPr>
          <p:cNvSpPr txBox="1"/>
          <p:nvPr/>
        </p:nvSpPr>
        <p:spPr>
          <a:xfrm>
            <a:off x="108036" y="8890055"/>
            <a:ext cx="369289" cy="326943"/>
          </a:xfrm>
          <a:prstGeom prst="rect">
            <a:avLst/>
          </a:prstGeom>
          <a:solidFill>
            <a:schemeClr val="accent2"/>
          </a:solidFill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7A7F97D-9F88-BB40-3C09-CC85ACD0C16E}"/>
              </a:ext>
            </a:extLst>
          </p:cNvPr>
          <p:cNvSpPr txBox="1"/>
          <p:nvPr/>
        </p:nvSpPr>
        <p:spPr>
          <a:xfrm>
            <a:off x="108036" y="11175362"/>
            <a:ext cx="645133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I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</a:t>
            </a:r>
            <a:r>
              <a:rPr lang="en-IN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2: Details of secondary structure predicted by I-TASSER: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1277437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ECF4EA9-CEA3-FC9F-01C3-FFC2DEBF7F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808" y="937404"/>
            <a:ext cx="6458282" cy="2565532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AAEA28A-ED72-C64C-4246-91327CE55E0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809" y="4008701"/>
            <a:ext cx="6458282" cy="2552831"/>
          </a:xfrm>
          <a:prstGeom prst="rect">
            <a:avLst/>
          </a:prstGeom>
          <a:ln>
            <a:solidFill>
              <a:srgbClr val="FF0000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D9502B9-77A4-C06C-36E1-95136BD0AB3E}"/>
              </a:ext>
            </a:extLst>
          </p:cNvPr>
          <p:cNvSpPr txBox="1"/>
          <p:nvPr/>
        </p:nvSpPr>
        <p:spPr>
          <a:xfrm>
            <a:off x="145419" y="594326"/>
            <a:ext cx="372166" cy="323165"/>
          </a:xfrm>
          <a:prstGeom prst="rect">
            <a:avLst/>
          </a:prstGeom>
          <a:solidFill>
            <a:schemeClr val="accent2"/>
          </a:solidFill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0DEAF44-71F3-B29A-C1F9-5DA86EC1AD9F}"/>
              </a:ext>
            </a:extLst>
          </p:cNvPr>
          <p:cNvSpPr txBox="1"/>
          <p:nvPr/>
        </p:nvSpPr>
        <p:spPr>
          <a:xfrm>
            <a:off x="162672" y="3665321"/>
            <a:ext cx="369289" cy="326943"/>
          </a:xfrm>
          <a:prstGeom prst="rect">
            <a:avLst/>
          </a:prstGeom>
          <a:solidFill>
            <a:schemeClr val="accent2"/>
          </a:solidFill>
        </p:spPr>
        <p:txBody>
          <a:bodyPr wrap="square" rtlCol="0">
            <a:spAutoFit/>
          </a:bodyPr>
          <a:lstStyle/>
          <a:p>
            <a:r>
              <a:rPr lang="en-I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06ECC41-1C40-7398-4655-AA5175450892}"/>
              </a:ext>
            </a:extLst>
          </p:cNvPr>
          <p:cNvSpPr txBox="1"/>
          <p:nvPr/>
        </p:nvSpPr>
        <p:spPr>
          <a:xfrm>
            <a:off x="198409" y="6809031"/>
            <a:ext cx="4235568" cy="4004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IN" sz="1800" kern="10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IN" sz="1800" kern="10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:Helix; </a:t>
            </a:r>
            <a:r>
              <a:rPr lang="en-IN" sz="1800" kern="100" dirty="0">
                <a:solidFill>
                  <a:srgbClr val="0000FF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en-IN" sz="1800" kern="10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:Strand; C:Coil</a:t>
            </a:r>
            <a:endParaRPr lang="en-IN" sz="2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EDA5A21-A373-DCE5-A5DD-54AD2BD987FF}"/>
              </a:ext>
            </a:extLst>
          </p:cNvPr>
          <p:cNvSpPr txBox="1"/>
          <p:nvPr/>
        </p:nvSpPr>
        <p:spPr>
          <a:xfrm>
            <a:off x="1" y="7567796"/>
            <a:ext cx="6858000" cy="36540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1200"/>
              </a:spcBef>
              <a:spcAft>
                <a:spcPts val="1000"/>
              </a:spcAft>
            </a:pPr>
            <a:r>
              <a:rPr lang="en-IN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I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</a:t>
            </a:r>
            <a:r>
              <a:rPr lang="en-IN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2: Details of secondary structure predicted by I-TASSER: A: Secondary structure of </a:t>
            </a:r>
            <a:r>
              <a:rPr lang="en-IN" sz="18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C_Os01g66890 in N22; B: </a:t>
            </a:r>
            <a:r>
              <a:rPr lang="en-IN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condary structure of </a:t>
            </a:r>
            <a:r>
              <a:rPr lang="en-IN" sz="18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C_Os01g66890 in IR64; C: </a:t>
            </a:r>
            <a:r>
              <a:rPr lang="en-IN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condary structure of LOC_Os01g71620 in N22; D:Secondary structure of </a:t>
            </a:r>
            <a:r>
              <a:rPr lang="en-IN" sz="18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C_Os01g71620 in IR64; E: </a:t>
            </a:r>
            <a:r>
              <a:rPr lang="en-IN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condary structure of LOC_Os01g63180 in N22</a:t>
            </a:r>
            <a:r>
              <a:rPr lang="en-IN" b="1" kern="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F:</a:t>
            </a:r>
            <a:r>
              <a:rPr lang="en-IN" sz="18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IN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condary structure of </a:t>
            </a:r>
            <a:r>
              <a:rPr lang="en-IN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C_Os01g63180 in IR64</a:t>
            </a:r>
            <a:endParaRPr lang="en-IN" sz="1800" b="1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Bef>
                <a:spcPts val="1200"/>
              </a:spcBef>
              <a:spcAft>
                <a:spcPts val="1000"/>
              </a:spcAft>
            </a:pPr>
            <a:r>
              <a:rPr lang="en-IN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IN" sz="1800" b="1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33158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77A925C-A7EB-0CA0-A46B-76B2A5D277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5441" y="206766"/>
            <a:ext cx="6045412" cy="226039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780BB9A-ED75-F0D5-A8F1-51A04869F88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594" t="18750" r="5703" b="35834"/>
          <a:stretch/>
        </p:blipFill>
        <p:spPr>
          <a:xfrm>
            <a:off x="405441" y="2467156"/>
            <a:ext cx="6045412" cy="2104844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187AC5C-9B77-6ED1-130F-40679B38B36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969" t="16389" r="6250" b="43056"/>
          <a:stretch/>
        </p:blipFill>
        <p:spPr>
          <a:xfrm>
            <a:off x="405441" y="4572000"/>
            <a:ext cx="6045412" cy="2104844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0479D54-F1B5-8FD3-9F79-AFEAA08E1C8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359" t="17500" r="6017" b="52778"/>
          <a:stretch/>
        </p:blipFill>
        <p:spPr>
          <a:xfrm>
            <a:off x="405441" y="6676845"/>
            <a:ext cx="6045412" cy="2104843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F3D82D0-AAFE-83CB-063F-4CCD973A1C4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985" t="19028" r="5860" b="48194"/>
          <a:stretch/>
        </p:blipFill>
        <p:spPr>
          <a:xfrm>
            <a:off x="405441" y="8781688"/>
            <a:ext cx="6045411" cy="2104843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FBD3E40-8A7C-E418-B719-59A4DE406657}"/>
              </a:ext>
            </a:extLst>
          </p:cNvPr>
          <p:cNvSpPr txBox="1"/>
          <p:nvPr/>
        </p:nvSpPr>
        <p:spPr>
          <a:xfrm>
            <a:off x="232913" y="10846461"/>
            <a:ext cx="6625087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3:</a:t>
            </a:r>
            <a:r>
              <a:rPr lang="en-IN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condary hairpin structure of the selected novel miRNAs</a:t>
            </a:r>
            <a:endParaRPr lang="en-IN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IN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35795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5C8BF23-959D-9ADA-BBCA-E1B9A37B691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374" t="17917" r="6563" b="50000"/>
          <a:stretch/>
        </p:blipFill>
        <p:spPr>
          <a:xfrm>
            <a:off x="431321" y="4780065"/>
            <a:ext cx="6045411" cy="2242868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D5D6994-0B93-D517-BEA7-B85E807188E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140" t="19027" r="6640" b="41806"/>
          <a:stretch/>
        </p:blipFill>
        <p:spPr>
          <a:xfrm>
            <a:off x="431321" y="7022933"/>
            <a:ext cx="6020384" cy="2278405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2E09B87-370E-7375-B7D1-781D5A7C17B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343" t="18889" r="7188" b="41667"/>
          <a:stretch/>
        </p:blipFill>
        <p:spPr>
          <a:xfrm>
            <a:off x="431321" y="390690"/>
            <a:ext cx="6045411" cy="2110970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3323C90-2DF1-1B06-182B-D597E804B7C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296" t="19445" r="7267" b="34999"/>
          <a:stretch/>
        </p:blipFill>
        <p:spPr>
          <a:xfrm>
            <a:off x="431321" y="2501660"/>
            <a:ext cx="6045411" cy="2242868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85B3884-087F-03ED-7046-B99E20E16646}"/>
              </a:ext>
            </a:extLst>
          </p:cNvPr>
          <p:cNvSpPr txBox="1"/>
          <p:nvPr/>
        </p:nvSpPr>
        <p:spPr>
          <a:xfrm>
            <a:off x="621103" y="9517811"/>
            <a:ext cx="6045410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3:</a:t>
            </a:r>
            <a:r>
              <a:rPr lang="en-IN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condary hairpin structure of the selected novel miRNAs</a:t>
            </a:r>
            <a:endParaRPr lang="en-IN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IN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22925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382FA7B0-BB6D-0A42-ADEC-4DB28F7BFC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9389" y="659614"/>
            <a:ext cx="2806256" cy="1721668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4C35E29-6EAA-ECE9-6E58-B10E02411CB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756" y="2481521"/>
            <a:ext cx="2775430" cy="1750056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A1ABE01-B718-D44D-1936-D1D583D3055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59392" y="2481521"/>
            <a:ext cx="2806256" cy="1750056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9F83E6E7-C85D-EC36-B543-2B176F3D7B9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1757" y="658203"/>
            <a:ext cx="2775430" cy="1750056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F1E8BDEF-E145-BE69-3AC0-80EC2CA672B5}"/>
              </a:ext>
            </a:extLst>
          </p:cNvPr>
          <p:cNvSpPr/>
          <p:nvPr/>
        </p:nvSpPr>
        <p:spPr>
          <a:xfrm>
            <a:off x="2852906" y="660399"/>
            <a:ext cx="195096" cy="15240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EEF88AC3-0D20-8B16-7DFC-E9820C74E72B}"/>
              </a:ext>
            </a:extLst>
          </p:cNvPr>
          <p:cNvSpPr/>
          <p:nvPr/>
        </p:nvSpPr>
        <p:spPr>
          <a:xfrm>
            <a:off x="6188772" y="656189"/>
            <a:ext cx="175612" cy="14104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7E815DC-20ED-D25B-5C21-99F3F7D8C423}"/>
              </a:ext>
            </a:extLst>
          </p:cNvPr>
          <p:cNvSpPr/>
          <p:nvPr/>
        </p:nvSpPr>
        <p:spPr>
          <a:xfrm>
            <a:off x="2853267" y="2476522"/>
            <a:ext cx="183717" cy="13121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354B1FB-F288-0E2C-A444-9724877DAF63}"/>
              </a:ext>
            </a:extLst>
          </p:cNvPr>
          <p:cNvSpPr/>
          <p:nvPr/>
        </p:nvSpPr>
        <p:spPr>
          <a:xfrm>
            <a:off x="6197239" y="2479908"/>
            <a:ext cx="170532" cy="22232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F0B1C57-B95C-C8E8-42F5-30EE1B788192}"/>
              </a:ext>
            </a:extLst>
          </p:cNvPr>
          <p:cNvSpPr txBox="1"/>
          <p:nvPr/>
        </p:nvSpPr>
        <p:spPr>
          <a:xfrm>
            <a:off x="271756" y="4347290"/>
            <a:ext cx="2857570" cy="368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Supplementary Fig. 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556BD2B-49E4-C391-6239-201DE2A9DE9B}"/>
              </a:ext>
            </a:extLst>
          </p:cNvPr>
          <p:cNvSpPr txBox="1"/>
          <p:nvPr/>
        </p:nvSpPr>
        <p:spPr>
          <a:xfrm rot="10800000" flipH="1" flipV="1">
            <a:off x="158475" y="5489677"/>
            <a:ext cx="6380348" cy="45499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Bef>
                <a:spcPts val="1200"/>
              </a:spcBef>
              <a:spcAft>
                <a:spcPts val="1000"/>
              </a:spcAft>
            </a:pPr>
            <a:r>
              <a:rPr lang="en-IN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. 4A: </a:t>
            </a:r>
            <a:r>
              <a:rPr lang="en-IN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ression level of selected novel miRNA under control conditions in comparison with reference gene in their respective genotypes</a:t>
            </a:r>
            <a:endParaRPr lang="en-IN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Bef>
                <a:spcPts val="1200"/>
              </a:spcBef>
              <a:spcAft>
                <a:spcPts val="1000"/>
              </a:spcAft>
            </a:pPr>
            <a:r>
              <a:rPr lang="en-IN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. 4B:</a:t>
            </a:r>
            <a:r>
              <a:rPr lang="en-IN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pression level of chr11_38583S14AStr under control conditions in eight genotypes</a:t>
            </a:r>
            <a:endParaRPr lang="en-IN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Bef>
                <a:spcPts val="1200"/>
              </a:spcBef>
              <a:spcAft>
                <a:spcPts val="1000"/>
              </a:spcAft>
            </a:pPr>
            <a:r>
              <a:rPr lang="en-IN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. 4C:</a:t>
            </a:r>
            <a:r>
              <a:rPr lang="en-IN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pression level of chr01_11911S14AStr under control conditions in eight genotypes</a:t>
            </a:r>
            <a:endParaRPr lang="en-IN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Bef>
                <a:spcPts val="1200"/>
              </a:spcBef>
              <a:spcAft>
                <a:spcPts val="1000"/>
              </a:spcAft>
            </a:pPr>
            <a:r>
              <a:rPr lang="en-IN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. 4D:</a:t>
            </a:r>
            <a:r>
              <a:rPr lang="en-IN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pression level of chr10_27362IR209a under control conditions in eight genotypes</a:t>
            </a:r>
            <a:endParaRPr lang="en-IN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Bef>
                <a:spcPts val="1200"/>
              </a:spcBef>
              <a:spcAft>
                <a:spcPts val="1000"/>
              </a:spcAft>
            </a:pPr>
            <a:endParaRPr lang="en-IN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Bef>
                <a:spcPts val="1200"/>
              </a:spcBef>
              <a:spcAft>
                <a:spcPts val="1000"/>
              </a:spcAft>
            </a:pPr>
            <a:endParaRPr lang="en-IN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48927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93</TotalTime>
  <Words>244</Words>
  <Application>Microsoft Office PowerPoint</Application>
  <PresentationFormat>Widescreen</PresentationFormat>
  <Paragraphs>23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EPESH JAISWAL</dc:creator>
  <cp:lastModifiedBy>DEEPESH JAISWAL</cp:lastModifiedBy>
  <cp:revision>6</cp:revision>
  <dcterms:created xsi:type="dcterms:W3CDTF">2023-01-13T10:47:40Z</dcterms:created>
  <dcterms:modified xsi:type="dcterms:W3CDTF">2023-07-06T05:03:12Z</dcterms:modified>
</cp:coreProperties>
</file>